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2C8503-C43E-94CC-6B2A-DAA1A4999F03}" name="Keane, Sean T" initials="SK" userId="S::skeane1@ic.ac.uk::4b207843-03b2-4fe5-b9e3-eab1bfb1e984" providerId="AD"/>
  <p188:author id="{25965566-DCB8-5FB7-0D4C-B52D2E943281}" name="Fulton, William T J" initials="FJ" userId="S::wfulton@ic.ac.uk::4d291324-378e-4ad8-aeb6-9357da62268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–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03"/>
    <p:restoredTop sz="94660"/>
  </p:normalViewPr>
  <p:slideViewPr>
    <p:cSldViewPr snapToGrid="0">
      <p:cViewPr varScale="1">
        <p:scale>
          <a:sx n="82" d="100"/>
          <a:sy n="82" d="100"/>
        </p:scale>
        <p:origin x="34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, Jooeun" userId="74932ba8-99c8-451f-9254-5909a1211fe7" providerId="ADAL" clId="{CD52A289-8FB7-5040-AC61-F2B49A34DC14}"/>
    <pc:docChg chg="modSld">
      <pc:chgData name="Han, Jooeun" userId="74932ba8-99c8-451f-9254-5909a1211fe7" providerId="ADAL" clId="{CD52A289-8FB7-5040-AC61-F2B49A34DC14}" dt="2026-01-26T16:02:08.331" v="13" actId="1076"/>
      <pc:docMkLst>
        <pc:docMk/>
      </pc:docMkLst>
      <pc:sldChg chg="addSp modSp mod">
        <pc:chgData name="Han, Jooeun" userId="74932ba8-99c8-451f-9254-5909a1211fe7" providerId="ADAL" clId="{CD52A289-8FB7-5040-AC61-F2B49A34DC14}" dt="2026-01-26T16:02:08.331" v="13" actId="1076"/>
        <pc:sldMkLst>
          <pc:docMk/>
          <pc:sldMk cId="217706116" sldId="265"/>
        </pc:sldMkLst>
        <pc:spChg chg="mod">
          <ac:chgData name="Han, Jooeun" userId="74932ba8-99c8-451f-9254-5909a1211fe7" providerId="ADAL" clId="{CD52A289-8FB7-5040-AC61-F2B49A34DC14}" dt="2026-01-26T16:01:49.686" v="0"/>
          <ac:spMkLst>
            <pc:docMk/>
            <pc:sldMk cId="217706116" sldId="265"/>
            <ac:spMk id="3" creationId="{76A77D39-1A01-BF17-640E-75BC65D51C32}"/>
          </ac:spMkLst>
        </pc:spChg>
        <pc:spChg chg="mod">
          <ac:chgData name="Han, Jooeun" userId="74932ba8-99c8-451f-9254-5909a1211fe7" providerId="ADAL" clId="{CD52A289-8FB7-5040-AC61-F2B49A34DC14}" dt="2026-01-26T16:01:49.686" v="0"/>
          <ac:spMkLst>
            <pc:docMk/>
            <pc:sldMk cId="217706116" sldId="265"/>
            <ac:spMk id="12" creationId="{7C2B9911-94E3-D068-AF1B-2125703341A1}"/>
          </ac:spMkLst>
        </pc:spChg>
        <pc:spChg chg="mod">
          <ac:chgData name="Han, Jooeun" userId="74932ba8-99c8-451f-9254-5909a1211fe7" providerId="ADAL" clId="{CD52A289-8FB7-5040-AC61-F2B49A34DC14}" dt="2026-01-26T16:01:55.970" v="2"/>
          <ac:spMkLst>
            <pc:docMk/>
            <pc:sldMk cId="217706116" sldId="265"/>
            <ac:spMk id="14" creationId="{6F9F45A5-32FE-4B01-7F12-6096A407C766}"/>
          </ac:spMkLst>
        </pc:spChg>
        <pc:spChg chg="mod">
          <ac:chgData name="Han, Jooeun" userId="74932ba8-99c8-451f-9254-5909a1211fe7" providerId="ADAL" clId="{CD52A289-8FB7-5040-AC61-F2B49A34DC14}" dt="2026-01-26T16:01:55.970" v="2"/>
          <ac:spMkLst>
            <pc:docMk/>
            <pc:sldMk cId="217706116" sldId="265"/>
            <ac:spMk id="15" creationId="{7F895EA1-A905-E3DF-4833-6CF88D30C307}"/>
          </ac:spMkLst>
        </pc:spChg>
        <pc:spChg chg="mod">
          <ac:chgData name="Han, Jooeun" userId="74932ba8-99c8-451f-9254-5909a1211fe7" providerId="ADAL" clId="{CD52A289-8FB7-5040-AC61-F2B49A34DC14}" dt="2026-01-26T16:02:01.908" v="10"/>
          <ac:spMkLst>
            <pc:docMk/>
            <pc:sldMk cId="217706116" sldId="265"/>
            <ac:spMk id="23" creationId="{96933972-771B-3048-41B2-38E8EBD4FD54}"/>
          </ac:spMkLst>
        </pc:spChg>
        <pc:spChg chg="mod">
          <ac:chgData name="Han, Jooeun" userId="74932ba8-99c8-451f-9254-5909a1211fe7" providerId="ADAL" clId="{CD52A289-8FB7-5040-AC61-F2B49A34DC14}" dt="2026-01-26T16:02:01.908" v="10"/>
          <ac:spMkLst>
            <pc:docMk/>
            <pc:sldMk cId="217706116" sldId="265"/>
            <ac:spMk id="24" creationId="{6BDA7884-FBCA-7525-2E52-7319DC418903}"/>
          </ac:spMkLst>
        </pc:spChg>
        <pc:spChg chg="mod">
          <ac:chgData name="Han, Jooeun" userId="74932ba8-99c8-451f-9254-5909a1211fe7" providerId="ADAL" clId="{CD52A289-8FB7-5040-AC61-F2B49A34DC14}" dt="2026-01-26T16:02:04.858" v="12"/>
          <ac:spMkLst>
            <pc:docMk/>
            <pc:sldMk cId="217706116" sldId="265"/>
            <ac:spMk id="26" creationId="{D0B170D3-E20B-565A-0345-1E456BE723D8}"/>
          </ac:spMkLst>
        </pc:spChg>
        <pc:spChg chg="mod">
          <ac:chgData name="Han, Jooeun" userId="74932ba8-99c8-451f-9254-5909a1211fe7" providerId="ADAL" clId="{CD52A289-8FB7-5040-AC61-F2B49A34DC14}" dt="2026-01-26T16:02:04.858" v="12"/>
          <ac:spMkLst>
            <pc:docMk/>
            <pc:sldMk cId="217706116" sldId="265"/>
            <ac:spMk id="27" creationId="{E323056C-1079-F15F-0B55-03303BDE61F9}"/>
          </ac:spMkLst>
        </pc:spChg>
      </pc:sldChg>
    </pc:docChg>
  </pc:docChgLst>
  <pc:docChgLst>
    <pc:chgData name="Layhadi, Janice A" userId="0a2e9531-7ec3-43d3-86a3-b0f00bbdd07c" providerId="ADAL" clId="{77757C92-1BF6-5290-B4EA-2BF7C0CA941C}"/>
    <pc:docChg chg="custSel modSld">
      <pc:chgData name="Layhadi, Janice A" userId="0a2e9531-7ec3-43d3-86a3-b0f00bbdd07c" providerId="ADAL" clId="{77757C92-1BF6-5290-B4EA-2BF7C0CA941C}" dt="2026-02-02T16:36:42.185" v="8" actId="114"/>
      <pc:docMkLst>
        <pc:docMk/>
      </pc:docMkLst>
      <pc:sldChg chg="delSp modSp mod">
        <pc:chgData name="Layhadi, Janice A" userId="0a2e9531-7ec3-43d3-86a3-b0f00bbdd07c" providerId="ADAL" clId="{77757C92-1BF6-5290-B4EA-2BF7C0CA941C}" dt="2026-02-02T16:36:42.185" v="8" actId="114"/>
        <pc:sldMkLst>
          <pc:docMk/>
          <pc:sldMk cId="217706116" sldId="265"/>
        </pc:sldMkLst>
        <pc:spChg chg="mod">
          <ac:chgData name="Layhadi, Janice A" userId="0a2e9531-7ec3-43d3-86a3-b0f00bbdd07c" providerId="ADAL" clId="{77757C92-1BF6-5290-B4EA-2BF7C0CA941C}" dt="2026-02-02T16:36:42.185" v="8" actId="114"/>
          <ac:spMkLst>
            <pc:docMk/>
            <pc:sldMk cId="217706116" sldId="265"/>
            <ac:spMk id="5" creationId="{8C445D8D-A10D-7AAE-FD1A-23566FF7A9E3}"/>
          </ac:spMkLst>
        </pc:spChg>
        <pc:spChg chg="mod">
          <ac:chgData name="Layhadi, Janice A" userId="0a2e9531-7ec3-43d3-86a3-b0f00bbdd07c" providerId="ADAL" clId="{77757C92-1BF6-5290-B4EA-2BF7C0CA941C}" dt="2026-02-02T16:36:39.345" v="6" actId="114"/>
          <ac:spMkLst>
            <pc:docMk/>
            <pc:sldMk cId="217706116" sldId="265"/>
            <ac:spMk id="7" creationId="{FDCFF561-CECA-4F4E-AF17-ABAC621202EC}"/>
          </ac:spMkLst>
        </pc:spChg>
        <pc:spChg chg="mod">
          <ac:chgData name="Layhadi, Janice A" userId="0a2e9531-7ec3-43d3-86a3-b0f00bbdd07c" providerId="ADAL" clId="{77757C92-1BF6-5290-B4EA-2BF7C0CA941C}" dt="2026-02-02T16:36:32.492" v="2" actId="114"/>
          <ac:spMkLst>
            <pc:docMk/>
            <pc:sldMk cId="217706116" sldId="265"/>
            <ac:spMk id="17" creationId="{13FD25C4-4DFF-8374-4836-EB041C5F9F83}"/>
          </ac:spMkLst>
        </pc:spChg>
        <pc:spChg chg="mod">
          <ac:chgData name="Layhadi, Janice A" userId="0a2e9531-7ec3-43d3-86a3-b0f00bbdd07c" providerId="ADAL" clId="{77757C92-1BF6-5290-B4EA-2BF7C0CA941C}" dt="2026-02-02T16:36:36.462" v="4" actId="114"/>
          <ac:spMkLst>
            <pc:docMk/>
            <pc:sldMk cId="217706116" sldId="265"/>
            <ac:spMk id="19" creationId="{2323B837-A071-47BF-C803-113E90B59383}"/>
          </ac:spMkLst>
        </pc:spChg>
        <pc:grpChg chg="del">
          <ac:chgData name="Layhadi, Janice A" userId="0a2e9531-7ec3-43d3-86a3-b0f00bbdd07c" providerId="ADAL" clId="{77757C92-1BF6-5290-B4EA-2BF7C0CA941C}" dt="2026-02-02T16:36:30.189" v="0" actId="478"/>
          <ac:grpSpMkLst>
            <pc:docMk/>
            <pc:sldMk cId="217706116" sldId="265"/>
            <ac:grpSpMk id="2" creationId="{C28EF480-A007-BE6D-E8E5-98B0A12108C3}"/>
          </ac:grpSpMkLst>
        </pc:grpChg>
        <pc:grpChg chg="del">
          <ac:chgData name="Layhadi, Janice A" userId="0a2e9531-7ec3-43d3-86a3-b0f00bbdd07c" providerId="ADAL" clId="{77757C92-1BF6-5290-B4EA-2BF7C0CA941C}" dt="2026-02-02T16:36:30.189" v="0" actId="478"/>
          <ac:grpSpMkLst>
            <pc:docMk/>
            <pc:sldMk cId="217706116" sldId="265"/>
            <ac:grpSpMk id="13" creationId="{B8F71CC8-9A0A-2546-83BF-D21281DF91A9}"/>
          </ac:grpSpMkLst>
        </pc:grpChg>
        <pc:grpChg chg="del">
          <ac:chgData name="Layhadi, Janice A" userId="0a2e9531-7ec3-43d3-86a3-b0f00bbdd07c" providerId="ADAL" clId="{77757C92-1BF6-5290-B4EA-2BF7C0CA941C}" dt="2026-02-02T16:36:30.189" v="0" actId="478"/>
          <ac:grpSpMkLst>
            <pc:docMk/>
            <pc:sldMk cId="217706116" sldId="265"/>
            <ac:grpSpMk id="16" creationId="{60E48B48-3AC8-BE91-884D-0A6A9463D3E1}"/>
          </ac:grpSpMkLst>
        </pc:grpChg>
        <pc:grpChg chg="del">
          <ac:chgData name="Layhadi, Janice A" userId="0a2e9531-7ec3-43d3-86a3-b0f00bbdd07c" providerId="ADAL" clId="{77757C92-1BF6-5290-B4EA-2BF7C0CA941C}" dt="2026-02-02T16:36:30.189" v="0" actId="478"/>
          <ac:grpSpMkLst>
            <pc:docMk/>
            <pc:sldMk cId="217706116" sldId="265"/>
            <ac:grpSpMk id="25" creationId="{FD1C4E30-8F7C-2B44-2BB1-D206DF5D62CB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8D21F-E96E-B947-B1D5-044ED282B3F2}" type="datetimeFigureOut">
              <a:rPr lang="en-US" smtClean="0"/>
              <a:t>2/2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503B47-3EBB-C14E-8E79-44CC56B81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148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82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56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33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8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306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07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8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845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999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0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446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4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A diagram of a number of genes&#10;&#10;Description automatically generated with medium confidence">
            <a:extLst>
              <a:ext uri="{FF2B5EF4-FFF2-40B4-BE49-F238E27FC236}">
                <a16:creationId xmlns:a16="http://schemas.microsoft.com/office/drawing/2014/main" id="{B65B2D78-5542-B549-4ACC-1DC3D5507FB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027"/>
          <a:stretch/>
        </p:blipFill>
        <p:spPr>
          <a:xfrm>
            <a:off x="4545433" y="614304"/>
            <a:ext cx="2095200" cy="196891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75FB3CC1-7E10-B48F-49EF-F8A8D7CA1B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45433" y="3226295"/>
            <a:ext cx="2095200" cy="20952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1C12E2B2-C12F-D36B-8F9E-6AEA28BD37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771" y="3218202"/>
            <a:ext cx="2084400" cy="2084400"/>
          </a:xfrm>
          <a:prstGeom prst="rect">
            <a:avLst/>
          </a:prstGeom>
        </p:spPr>
      </p:pic>
      <p:pic>
        <p:nvPicPr>
          <p:cNvPr id="32" name="Picture 31" descr="A diagram of a number of genes&#10;&#10;Description automatically generated with medium confidence">
            <a:extLst>
              <a:ext uri="{FF2B5EF4-FFF2-40B4-BE49-F238E27FC236}">
                <a16:creationId xmlns:a16="http://schemas.microsoft.com/office/drawing/2014/main" id="{3D1C7C7E-DEC5-A04A-FBE4-B5169378C9B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6027"/>
          <a:stretch/>
        </p:blipFill>
        <p:spPr>
          <a:xfrm>
            <a:off x="2394984" y="614304"/>
            <a:ext cx="2095200" cy="1968918"/>
          </a:xfrm>
          <a:prstGeom prst="rect">
            <a:avLst/>
          </a:prstGeom>
        </p:spPr>
      </p:pic>
      <p:pic>
        <p:nvPicPr>
          <p:cNvPr id="4" name="Picture 3" descr="A diagram of a number of genes&#10;&#10;Description automatically generated">
            <a:extLst>
              <a:ext uri="{FF2B5EF4-FFF2-40B4-BE49-F238E27FC236}">
                <a16:creationId xmlns:a16="http://schemas.microsoft.com/office/drawing/2014/main" id="{ED17AC45-67E7-7A96-5147-E61B4F9D2E2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6043"/>
          <a:stretch/>
        </p:blipFill>
        <p:spPr>
          <a:xfrm>
            <a:off x="262803" y="615928"/>
            <a:ext cx="2095541" cy="196891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C445D8D-A10D-7AAE-FD1A-23566FF7A9E3}"/>
              </a:ext>
            </a:extLst>
          </p:cNvPr>
          <p:cNvSpPr/>
          <p:nvPr/>
        </p:nvSpPr>
        <p:spPr>
          <a:xfrm>
            <a:off x="262804" y="214601"/>
            <a:ext cx="2095540" cy="27470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tural Fel d 1 vs. Fel d 1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D56E745-7B14-DC0D-33FE-D4D88A35F385}"/>
              </a:ext>
            </a:extLst>
          </p:cNvPr>
          <p:cNvSpPr/>
          <p:nvPr/>
        </p:nvSpPr>
        <p:spPr>
          <a:xfrm>
            <a:off x="2404458" y="214601"/>
            <a:ext cx="2095200" cy="274703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9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nstimulated vs. natural Fel d 1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DCFF561-CECA-4F4E-AF17-ABAC621202EC}"/>
              </a:ext>
            </a:extLst>
          </p:cNvPr>
          <p:cNvSpPr/>
          <p:nvPr/>
        </p:nvSpPr>
        <p:spPr>
          <a:xfrm>
            <a:off x="4545772" y="214601"/>
            <a:ext cx="2095200" cy="27470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nstimulated vs. Fel d 1 </a:t>
            </a:r>
            <a:r>
              <a:rPr kumimoji="0" lang="en-US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P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B55250D-551F-28AA-56A0-BDEA6A0753C2}"/>
              </a:ext>
            </a:extLst>
          </p:cNvPr>
          <p:cNvSpPr/>
          <p:nvPr/>
        </p:nvSpPr>
        <p:spPr>
          <a:xfrm>
            <a:off x="262801" y="489304"/>
            <a:ext cx="2095539" cy="2095541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A1A5EB7-EBD7-2979-DE2D-AF84992D7EC3}"/>
              </a:ext>
            </a:extLst>
          </p:cNvPr>
          <p:cNvSpPr/>
          <p:nvPr/>
        </p:nvSpPr>
        <p:spPr>
          <a:xfrm>
            <a:off x="2404458" y="489304"/>
            <a:ext cx="2095539" cy="2095541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2919A73-5419-8890-B124-E564223C328C}"/>
              </a:ext>
            </a:extLst>
          </p:cNvPr>
          <p:cNvSpPr/>
          <p:nvPr/>
        </p:nvSpPr>
        <p:spPr>
          <a:xfrm>
            <a:off x="4545772" y="489303"/>
            <a:ext cx="2095539" cy="2095541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2764260-A014-A662-56E2-63F821A73270}"/>
              </a:ext>
            </a:extLst>
          </p:cNvPr>
          <p:cNvSpPr txBox="1"/>
          <p:nvPr/>
        </p:nvSpPr>
        <p:spPr>
          <a:xfrm>
            <a:off x="-34838" y="9567446"/>
            <a:ext cx="35493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Supplementary Figure 3 - Monocyte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3FD25C4-4DFF-8374-4836-EB041C5F9F83}"/>
              </a:ext>
            </a:extLst>
          </p:cNvPr>
          <p:cNvSpPr/>
          <p:nvPr/>
        </p:nvSpPr>
        <p:spPr>
          <a:xfrm>
            <a:off x="262465" y="2908070"/>
            <a:ext cx="2095540" cy="27470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tural Fel d 1 vs. Fel d 1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4669EA4-67EE-D728-2918-A17F16606928}"/>
              </a:ext>
            </a:extLst>
          </p:cNvPr>
          <p:cNvSpPr/>
          <p:nvPr/>
        </p:nvSpPr>
        <p:spPr>
          <a:xfrm>
            <a:off x="2404119" y="2908070"/>
            <a:ext cx="2095200" cy="274703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0" lang="en-US" sz="9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nstimulated vs. natural Fel d 1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323B837-A071-47BF-C803-113E90B59383}"/>
              </a:ext>
            </a:extLst>
          </p:cNvPr>
          <p:cNvSpPr/>
          <p:nvPr/>
        </p:nvSpPr>
        <p:spPr>
          <a:xfrm>
            <a:off x="4545433" y="2908070"/>
            <a:ext cx="2095200" cy="27470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nstimulated vs. Fel d 1 </a:t>
            </a:r>
            <a:r>
              <a:rPr kumimoji="0" lang="en-US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P 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C5974C2-1E40-040F-97E2-D870804B3FEC}"/>
              </a:ext>
            </a:extLst>
          </p:cNvPr>
          <p:cNvSpPr/>
          <p:nvPr/>
        </p:nvSpPr>
        <p:spPr>
          <a:xfrm>
            <a:off x="262126" y="3182774"/>
            <a:ext cx="2095875" cy="2198958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9FF0F806-3A2F-549C-90C7-2D8C4E46B1EE}"/>
              </a:ext>
            </a:extLst>
          </p:cNvPr>
          <p:cNvSpPr/>
          <p:nvPr/>
        </p:nvSpPr>
        <p:spPr>
          <a:xfrm>
            <a:off x="2404119" y="3182773"/>
            <a:ext cx="2095539" cy="2198959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5D8266B-2240-98CD-2357-B0C78FF2E62B}"/>
              </a:ext>
            </a:extLst>
          </p:cNvPr>
          <p:cNvSpPr/>
          <p:nvPr/>
        </p:nvSpPr>
        <p:spPr>
          <a:xfrm>
            <a:off x="4545433" y="3182773"/>
            <a:ext cx="2095539" cy="2198959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" name="Picture 29" descr="A chart of different colors&#10;&#10;Description automatically generated with medium confidence">
            <a:extLst>
              <a:ext uri="{FF2B5EF4-FFF2-40B4-BE49-F238E27FC236}">
                <a16:creationId xmlns:a16="http://schemas.microsoft.com/office/drawing/2014/main" id="{6835CEA6-9F9B-6929-9F60-E45E4CDCB1E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12568" y="3216659"/>
            <a:ext cx="2085943" cy="2085943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E069CF12-B9F7-0398-0A36-DD082AFD7CA5}"/>
              </a:ext>
            </a:extLst>
          </p:cNvPr>
          <p:cNvSpPr txBox="1"/>
          <p:nvPr/>
        </p:nvSpPr>
        <p:spPr>
          <a:xfrm>
            <a:off x="-52422" y="-6652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049EE05-EF6B-3291-BEDB-A3DFE7C6F106}"/>
              </a:ext>
            </a:extLst>
          </p:cNvPr>
          <p:cNvSpPr txBox="1"/>
          <p:nvPr/>
        </p:nvSpPr>
        <p:spPr>
          <a:xfrm>
            <a:off x="-52422" y="2754478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17706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743</TotalTime>
  <Words>57</Words>
  <Application>Microsoft Macintosh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yhadi, Janice A</dc:creator>
  <cp:lastModifiedBy>Layhadi, Janice A</cp:lastModifiedBy>
  <cp:revision>38</cp:revision>
  <cp:lastPrinted>2023-09-27T12:15:59Z</cp:lastPrinted>
  <dcterms:created xsi:type="dcterms:W3CDTF">2023-09-26T16:40:01Z</dcterms:created>
  <dcterms:modified xsi:type="dcterms:W3CDTF">2026-02-02T16:36:42Z</dcterms:modified>
</cp:coreProperties>
</file>